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9628B4-1AE2-4B8F-8D24-30DC9208B95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EEF3F4-BE5C-4625-9DE4-EFB32DD75A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925453-6019-48CE-90BA-35BDDA946F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CF6C15-5412-4FA5-93A4-626F08F614C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CF8DDD-BBF5-4C3B-9C4B-84BBC74102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BC5F60-8866-4678-A1FB-4F57AEA585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F830B6-3750-4D3C-AD61-837EBE0344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673DC0-27B0-4BFF-AE22-F898CAF7A6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28929B-0446-463E-8C5B-1416EB4D27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6DD0DA-B39D-4BE6-99C7-AF367A5AB9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14106B-4C7E-4F7C-88C5-634B0D5DE5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69B2BB-AC3A-451B-A46F-089BBFA69E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F475A4D-C108-440C-BB04-B5B445C6FDB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824040" y="82440"/>
            <a:ext cx="73990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Fisher’s exact test for biological themes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57960" y="5602320"/>
            <a:ext cx="895140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200" spc="-1" strike="noStrike">
                <a:solidFill>
                  <a:srgbClr val="000000"/>
                </a:solidFill>
                <a:latin typeface="Arial"/>
              </a:rPr>
              <a:t>1. Global Test for all terms of a selected system (GO, Biocarta etc)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200" spc="-1" strike="noStrike">
                <a:solidFill>
                  <a:srgbClr val="000000"/>
                </a:solidFill>
                <a:latin typeface="Arial"/>
              </a:rPr>
              <a:t>2. Pathway or PSCP scoped “local” test for loaded CRI datasets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766880" y="3443400"/>
            <a:ext cx="5943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757600" y="1457280"/>
            <a:ext cx="0" cy="387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662360" y="1457280"/>
            <a:ext cx="0" cy="3900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6491160" y="1457280"/>
            <a:ext cx="0" cy="3940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766880" y="4500720"/>
            <a:ext cx="5943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766880" y="2295360"/>
            <a:ext cx="5943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228840" y="2733840"/>
            <a:ext cx="12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ist Hit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6559920" y="2727360"/>
            <a:ext cx="1107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ist Tot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114720" y="4649760"/>
            <a:ext cx="12567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opula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it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6578640" y="4651200"/>
            <a:ext cx="12567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opula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ot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997280" y="2724120"/>
            <a:ext cx="57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026080" y="3743280"/>
            <a:ext cx="47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445200" y="1685880"/>
            <a:ext cx="57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5274360" y="1685880"/>
            <a:ext cx="47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215880" y="1081080"/>
            <a:ext cx="278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n a Pathway or GO Ter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rot="16200000">
            <a:off x="501840" y="3314880"/>
            <a:ext cx="179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n the Gene Li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757600" y="1457280"/>
            <a:ext cx="3733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H="1">
            <a:off x="1753920" y="2295360"/>
            <a:ext cx="12600" cy="2205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853720" y="628560"/>
            <a:ext cx="3583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2x2 Contingency Table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852640" y="2443320"/>
            <a:ext cx="1801800" cy="90000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11-07T21:17:39Z</dcterms:created>
  <dc:creator>MingYi</dc:creator>
  <dc:description/>
  <dc:language>en-US</dc:language>
  <cp:lastModifiedBy>MingYi</cp:lastModifiedBy>
  <dcterms:modified xsi:type="dcterms:W3CDTF">2005-11-09T22:18:59Z</dcterms:modified>
  <cp:revision>2</cp:revision>
  <dc:subject/>
  <dc:title>Slide 1</dc:title>
</cp:coreProperties>
</file>